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7504A72-1167-4CFC-8F87-44FB991730D5}" v="1" dt="2023-08-03T02:39:33.85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273" autoAdjust="0"/>
  </p:normalViewPr>
  <p:slideViewPr>
    <p:cSldViewPr snapToGrid="0">
      <p:cViewPr varScale="1">
        <p:scale>
          <a:sx n="110" d="100"/>
          <a:sy n="110" d="100"/>
        </p:scale>
        <p:origin x="17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임승혁" userId="50080d77-0d6e-4880-96a7-58e4dd6aba5c" providerId="ADAL" clId="{1E9C803A-C456-4DA3-BD29-C0DC4AD5AAB2}"/>
    <pc:docChg chg="custSel modSld">
      <pc:chgData name="임승혁" userId="50080d77-0d6e-4880-96a7-58e4dd6aba5c" providerId="ADAL" clId="{1E9C803A-C456-4DA3-BD29-C0DC4AD5AAB2}" dt="2023-07-03T03:27:08.445" v="314" actId="1036"/>
      <pc:docMkLst>
        <pc:docMk/>
      </pc:docMkLst>
      <pc:sldChg chg="addSp delSp modSp mod">
        <pc:chgData name="임승혁" userId="50080d77-0d6e-4880-96a7-58e4dd6aba5c" providerId="ADAL" clId="{1E9C803A-C456-4DA3-BD29-C0DC4AD5AAB2}" dt="2023-07-03T03:27:08.445" v="314" actId="1036"/>
        <pc:sldMkLst>
          <pc:docMk/>
          <pc:sldMk cId="3431822228" sldId="256"/>
        </pc:sldMkLst>
        <pc:spChg chg="mod">
          <ac:chgData name="임승혁" userId="50080d77-0d6e-4880-96a7-58e4dd6aba5c" providerId="ADAL" clId="{1E9C803A-C456-4DA3-BD29-C0DC4AD5AAB2}" dt="2023-07-03T03:26:36.138" v="224" actId="20577"/>
          <ac:spMkLst>
            <pc:docMk/>
            <pc:sldMk cId="3431822228" sldId="256"/>
            <ac:spMk id="5" creationId="{A2B06BF4-8BA6-EA6E-3403-93919840A4E6}"/>
          </ac:spMkLst>
        </pc:spChg>
        <pc:spChg chg="mod">
          <ac:chgData name="임승혁" userId="50080d77-0d6e-4880-96a7-58e4dd6aba5c" providerId="ADAL" clId="{1E9C803A-C456-4DA3-BD29-C0DC4AD5AAB2}" dt="2023-07-03T03:27:08.445" v="314" actId="1036"/>
          <ac:spMkLst>
            <pc:docMk/>
            <pc:sldMk cId="3431822228" sldId="256"/>
            <ac:spMk id="6" creationId="{BF25BFE9-B681-C1BE-A27A-ABB17CCE3961}"/>
          </ac:spMkLst>
        </pc:spChg>
        <pc:picChg chg="add mod">
          <ac:chgData name="임승혁" userId="50080d77-0d6e-4880-96a7-58e4dd6aba5c" providerId="ADAL" clId="{1E9C803A-C456-4DA3-BD29-C0DC4AD5AAB2}" dt="2023-07-03T03:25:02.165" v="40" actId="1035"/>
          <ac:picMkLst>
            <pc:docMk/>
            <pc:sldMk cId="3431822228" sldId="256"/>
            <ac:picMk id="3" creationId="{2A25DD46-4C31-81B7-A0A9-27AA40CAB7A2}"/>
          </ac:picMkLst>
        </pc:picChg>
        <pc:picChg chg="del">
          <ac:chgData name="임승혁" userId="50080d77-0d6e-4880-96a7-58e4dd6aba5c" providerId="ADAL" clId="{1E9C803A-C456-4DA3-BD29-C0DC4AD5AAB2}" dt="2023-07-03T03:24:53.100" v="3" actId="478"/>
          <ac:picMkLst>
            <pc:docMk/>
            <pc:sldMk cId="3431822228" sldId="256"/>
            <ac:picMk id="4" creationId="{5128FDE4-C49C-3003-319C-CA1C90D4F163}"/>
          </ac:picMkLst>
        </pc:picChg>
        <pc:cxnChg chg="mod">
          <ac:chgData name="임승혁" userId="50080d77-0d6e-4880-96a7-58e4dd6aba5c" providerId="ADAL" clId="{1E9C803A-C456-4DA3-BD29-C0DC4AD5AAB2}" dt="2023-07-03T03:27:08.445" v="314" actId="1036"/>
          <ac:cxnSpMkLst>
            <pc:docMk/>
            <pc:sldMk cId="3431822228" sldId="256"/>
            <ac:cxnSpMk id="8" creationId="{ACE8C632-8FAA-0062-92DC-0D02AE043F86}"/>
          </ac:cxnSpMkLst>
        </pc:cxnChg>
      </pc:sldChg>
    </pc:docChg>
  </pc:docChgLst>
  <pc:docChgLst>
    <pc:chgData name="임승혁" userId="50080d77-0d6e-4880-96a7-58e4dd6aba5c" providerId="ADAL" clId="{17504A72-1167-4CFC-8F87-44FB991730D5}"/>
    <pc:docChg chg="modSld">
      <pc:chgData name="임승혁" userId="50080d77-0d6e-4880-96a7-58e4dd6aba5c" providerId="ADAL" clId="{17504A72-1167-4CFC-8F87-44FB991730D5}" dt="2023-08-03T02:39:33.852" v="0" actId="14826"/>
      <pc:docMkLst>
        <pc:docMk/>
      </pc:docMkLst>
      <pc:sldChg chg="modSp">
        <pc:chgData name="임승혁" userId="50080d77-0d6e-4880-96a7-58e4dd6aba5c" providerId="ADAL" clId="{17504A72-1167-4CFC-8F87-44FB991730D5}" dt="2023-08-03T02:39:33.852" v="0" actId="14826"/>
        <pc:sldMkLst>
          <pc:docMk/>
          <pc:sldMk cId="3431822228" sldId="256"/>
        </pc:sldMkLst>
        <pc:picChg chg="mod">
          <ac:chgData name="임승혁" userId="50080d77-0d6e-4880-96a7-58e4dd6aba5c" providerId="ADAL" clId="{17504A72-1167-4CFC-8F87-44FB991730D5}" dt="2023-08-03T02:39:33.852" v="0" actId="14826"/>
          <ac:picMkLst>
            <pc:docMk/>
            <pc:sldMk cId="3431822228" sldId="256"/>
            <ac:picMk id="3" creationId="{2A25DD46-4C31-81B7-A0A9-27AA40CAB7A2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2A8ACC-800C-411D-A947-8DB322DD5BD6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5FC58-540C-479B-B142-3AE2D6087C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422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55FC58-540C-479B-B142-3AE2D6087CD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6976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791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438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24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169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31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640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34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178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4178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138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59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336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1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2B06BF4-8BA6-EA6E-3403-93919840A4E6}"/>
              </a:ext>
            </a:extLst>
          </p:cNvPr>
          <p:cNvSpPr txBox="1"/>
          <p:nvPr/>
        </p:nvSpPr>
        <p:spPr>
          <a:xfrm>
            <a:off x="134936" y="33637"/>
            <a:ext cx="8753273" cy="8728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l Digital Content 11. Numbers of deceased-donor liver transplantation and the waitlist times in South Korea.</a:t>
            </a:r>
            <a:endParaRPr lang="ko-KR" altLang="ko-KR" sz="1800" b="1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25BFE9-B681-C1BE-A27A-ABB17CCE3961}"/>
              </a:ext>
            </a:extLst>
          </p:cNvPr>
          <p:cNvSpPr txBox="1"/>
          <p:nvPr/>
        </p:nvSpPr>
        <p:spPr>
          <a:xfrm>
            <a:off x="134936" y="6591200"/>
            <a:ext cx="8753273" cy="3191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LT, liver transplantation; DDLT, deceased-donor liver transplantation; LDLT, living-donor liver transplantation.</a:t>
            </a:r>
            <a:endParaRPr lang="ko-KR" altLang="ko-KR" sz="105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ACE8C632-8FAA-0062-92DC-0D02AE043F86}"/>
              </a:ext>
            </a:extLst>
          </p:cNvPr>
          <p:cNvCxnSpPr>
            <a:cxnSpLocks/>
          </p:cNvCxnSpPr>
          <p:nvPr/>
        </p:nvCxnSpPr>
        <p:spPr>
          <a:xfrm>
            <a:off x="134936" y="6662450"/>
            <a:ext cx="8495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3" name="그림 2">
            <a:extLst>
              <a:ext uri="{FF2B5EF4-FFF2-40B4-BE49-F238E27FC236}">
                <a16:creationId xmlns:a16="http://schemas.microsoft.com/office/drawing/2014/main" id="{2A25DD46-4C31-81B7-A0A9-27AA40CAB7A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75" y="1071404"/>
            <a:ext cx="8996388" cy="5555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1822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3</TotalTime>
  <Words>36</Words>
  <Application>Microsoft Office PowerPoint</Application>
  <PresentationFormat>사용자 지정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im Seung Hyuk</dc:creator>
  <cp:lastModifiedBy>임승혁</cp:lastModifiedBy>
  <cp:revision>5</cp:revision>
  <dcterms:created xsi:type="dcterms:W3CDTF">2023-05-09T01:23:50Z</dcterms:created>
  <dcterms:modified xsi:type="dcterms:W3CDTF">2023-08-03T02:39:36Z</dcterms:modified>
</cp:coreProperties>
</file>